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822E35-D39F-4E10-9508-0A5B128E6058}" v="2" dt="2025-11-02T22:17:42.252"/>
    <p1510:client id="{BFB157A3-EDF0-45F6-ABC2-3EFB301C0595}" v="3" dt="2025-11-02T21:18:48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96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custSel addSld modSld">
      <pc:chgData name="Sobel, Raymond" userId="682ea7fd-2081-4ef7-9ccf-cc036b672067" providerId="ADAL" clId="{327064EF-D6E0-4CA7-937D-5219C7D36AD4}" dt="2025-11-02T22:20:15.806" v="298" actId="20577"/>
      <pc:docMkLst>
        <pc:docMk/>
      </pc:docMkLst>
      <pc:sldChg chg="addSp delSp modSp new mod">
        <pc:chgData name="Sobel, Raymond" userId="682ea7fd-2081-4ef7-9ccf-cc036b672067" providerId="ADAL" clId="{327064EF-D6E0-4CA7-937D-5219C7D36AD4}" dt="2025-11-02T22:20:15.806" v="298" actId="20577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2:20:15.806" v="298" actId="20577"/>
          <ac:spMkLst>
            <pc:docMk/>
            <pc:sldMk cId="3744564216" sldId="256"/>
            <ac:spMk id="4" creationId="{2571C028-8524-3A49-B9BB-8EE9AB795E3A}"/>
          </ac:spMkLst>
        </pc:spChg>
        <pc:picChg chg="add del mod">
          <ac:chgData name="Sobel, Raymond" userId="682ea7fd-2081-4ef7-9ccf-cc036b672067" providerId="ADAL" clId="{327064EF-D6E0-4CA7-937D-5219C7D36AD4}" dt="2025-11-02T22:16:46.607" v="138" actId="478"/>
          <ac:picMkLst>
            <pc:docMk/>
            <pc:sldMk cId="3744564216" sldId="256"/>
            <ac:picMk id="3" creationId="{A11ABE44-0B99-3AE0-A94A-378154AA6F58}"/>
          </ac:picMkLst>
        </pc:picChg>
        <pc:picChg chg="add mod">
          <ac:chgData name="Sobel, Raymond" userId="682ea7fd-2081-4ef7-9ccf-cc036b672067" providerId="ADAL" clId="{327064EF-D6E0-4CA7-937D-5219C7D36AD4}" dt="2025-11-02T22:19:33.731" v="280" actId="1036"/>
          <ac:picMkLst>
            <pc:docMk/>
            <pc:sldMk cId="3744564216" sldId="256"/>
            <ac:picMk id="5" creationId="{98357546-B6F2-E0E3-70C7-06E99685DE2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127594" y="198469"/>
            <a:ext cx="3746496" cy="6555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.Histopathological findings in muscle biopsy from the patient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Light microscopy analysis demon-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trated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: (A) marked fiber size variability, some fibers containing multiple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ytoplas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 mic vacuoles, internalized nuclei, fibers splitting, and increased endomysial connective tissue; (B) low granular or dotted aspect of the muscle cell mem- brane; (C) absence of myofibrillar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isor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anization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and low accumulation of mitochondria in the periphery of the fibers; (D) dystrophin labeling on vacuoles and muscle fiber membranes; (E) deposition of complement C5b-9 within vacuoles and along muscle fiber membranes; (F and G) positive labeling of p62 and LAMP-2 on autophagic vacuoles and membranes of abnormal fibers; (H) low acid phosphatase activity within vacuoles. Abbreviations: C5b-9, comp-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ement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membrane attack complex; DYS, dystrophin; GT, Gömöri trichrome; H&amp;E, hematoxylin and eosin; LAMP-2,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yso</a:t>
            </a:r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- some-associated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embrane protein 2; NADH-TR, reduced nicotinamide adenine dinucleotide dehydrogenase-tetrazolium reductase. Scale bar = 200 µm for all panels. 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8357546-B6F2-E0E3-70C7-06E99685DE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44970" y="205557"/>
            <a:ext cx="8190316" cy="6126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9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2:20:22Z</dcterms:modified>
</cp:coreProperties>
</file>